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es-C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editar el estilo de subtítulo del patrón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009496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41553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4950302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9698237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525758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33565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084030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3361071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23016480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880840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CL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CL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928968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CL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CL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197D19-7910-4E29-9901-635BEE58789B}" type="datetimeFigureOut">
              <a:rPr lang="es-CL" smtClean="0"/>
              <a:t>27-03-2017</a:t>
            </a:fld>
            <a:endParaRPr lang="es-CL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CL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089F2F-F923-4D2B-8A12-B1EF2710A88F}" type="slidenum">
              <a:rPr lang="es-CL" smtClean="0"/>
              <a:t>‹Nº›</a:t>
            </a:fld>
            <a:endParaRPr lang="es-CL"/>
          </a:p>
        </p:txBody>
      </p:sp>
    </p:spTree>
    <p:extLst>
      <p:ext uri="{BB962C8B-B14F-4D97-AF65-F5344CB8AC3E}">
        <p14:creationId xmlns:p14="http://schemas.microsoft.com/office/powerpoint/2010/main" val="1755837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C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4127" y="136714"/>
            <a:ext cx="8472211" cy="6039697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186193" y="2469295"/>
            <a:ext cx="40014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HOMA-S </a:t>
            </a:r>
            <a:r>
              <a:rPr lang="en-US" sz="2400" dirty="0"/>
              <a:t>Index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3150624" y="5924271"/>
            <a:ext cx="170290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Lower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5314627" y="5902963"/>
            <a:ext cx="248895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Middle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500741" y="5902963"/>
            <a:ext cx="18742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Upper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4143104" y="6177309"/>
            <a:ext cx="80488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dirty="0"/>
              <a:t>                        Leptin </a:t>
            </a:r>
            <a:r>
              <a:rPr lang="es-CL" sz="2400" dirty="0"/>
              <a:t>(ng/ml)</a:t>
            </a:r>
            <a:endParaRPr lang="en-US" sz="2400" dirty="0"/>
          </a:p>
        </p:txBody>
      </p:sp>
      <p:sp>
        <p:nvSpPr>
          <p:cNvPr id="8" name="CuadroTexto 7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4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42756608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43137" y="642937"/>
            <a:ext cx="7705725" cy="557212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513729" y="3046195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CSi </a:t>
            </a:r>
            <a:r>
              <a:rPr lang="en-US" sz="2400" dirty="0"/>
              <a:t>Index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3082888" y="5966840"/>
            <a:ext cx="13795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Lower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5179467" y="5966839"/>
            <a:ext cx="248895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dirty="0"/>
              <a:t>          </a:t>
            </a:r>
            <a:r>
              <a:rPr lang="en-US" dirty="0"/>
              <a:t>Middle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8216313" y="5984229"/>
            <a:ext cx="18742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Upper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3772674" y="6396335"/>
            <a:ext cx="80488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dirty="0"/>
              <a:t>                        Leptin </a:t>
            </a:r>
            <a:r>
              <a:rPr lang="es-CL" sz="2400" dirty="0"/>
              <a:t>(ng/ml)</a:t>
            </a:r>
            <a:endParaRPr lang="en-US" sz="2400" dirty="0"/>
          </a:p>
        </p:txBody>
      </p:sp>
      <p:sp>
        <p:nvSpPr>
          <p:cNvPr id="9" name="CuadroTexto 8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4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7921136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04003" y="544341"/>
            <a:ext cx="7894154" cy="5708821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294365" y="2668079"/>
            <a:ext cx="40014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HOMA-S </a:t>
            </a:r>
            <a:r>
              <a:rPr lang="en-US" sz="2400" dirty="0"/>
              <a:t>Index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3039006" y="5909303"/>
            <a:ext cx="186429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Lower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5029822" y="5909302"/>
            <a:ext cx="248895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Middle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7977401" y="5909302"/>
            <a:ext cx="18742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Upper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4661433" y="6251298"/>
            <a:ext cx="80488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dirty="0"/>
              <a:t>Total Adiponectin </a:t>
            </a:r>
            <a:r>
              <a:rPr lang="es-CL" sz="2400" dirty="0"/>
              <a:t>(µg/ml)</a:t>
            </a:r>
            <a:r>
              <a:rPr lang="en-US" sz="2400" dirty="0"/>
              <a:t> 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4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39660048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07600" y="503579"/>
            <a:ext cx="8014001" cy="571169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-92243" y="2385230"/>
            <a:ext cx="41852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CSi </a:t>
            </a:r>
            <a:r>
              <a:rPr lang="en-US" sz="2400" dirty="0"/>
              <a:t>Index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5011774" y="5900765"/>
            <a:ext cx="248895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Middle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7898294" y="5900764"/>
            <a:ext cx="187426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Upper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2743200" y="5900763"/>
            <a:ext cx="206979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Lower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4812992" y="6202016"/>
            <a:ext cx="80488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dirty="0"/>
              <a:t>Total Adiponectin </a:t>
            </a:r>
            <a:r>
              <a:rPr lang="es-CL" sz="2400" dirty="0"/>
              <a:t>(µg/ml)</a:t>
            </a:r>
            <a:r>
              <a:rPr lang="en-US" sz="2400" dirty="0"/>
              <a:t> 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8878957" y="6366049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4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40960409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43125" y="566737"/>
            <a:ext cx="7905750" cy="5724525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254608" y="2668079"/>
            <a:ext cx="4001400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HOMA-S </a:t>
            </a:r>
            <a:r>
              <a:rPr lang="en-US" sz="2400" dirty="0"/>
              <a:t>Index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2782957" y="5947403"/>
            <a:ext cx="22533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Lower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5053647" y="5885464"/>
            <a:ext cx="248895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Middle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7559920" y="5885464"/>
            <a:ext cx="2807008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    Upper</a:t>
            </a:r>
          </a:p>
        </p:txBody>
      </p:sp>
      <p:sp>
        <p:nvSpPr>
          <p:cNvPr id="7" name="CuadroTexto 6"/>
          <p:cNvSpPr txBox="1"/>
          <p:nvPr/>
        </p:nvSpPr>
        <p:spPr>
          <a:xfrm>
            <a:off x="1825073" y="6254796"/>
            <a:ext cx="80488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dirty="0"/>
              <a:t>                        High Molecular Weight Adiponectin </a:t>
            </a:r>
            <a:r>
              <a:rPr lang="es-CL" sz="2400" dirty="0"/>
              <a:t>(µg/ml)</a:t>
            </a:r>
            <a:endParaRPr lang="en-US" sz="2400" dirty="0"/>
          </a:p>
        </p:txBody>
      </p:sp>
      <p:sp>
        <p:nvSpPr>
          <p:cNvPr id="8" name="CuadroTexto 7"/>
          <p:cNvSpPr txBox="1"/>
          <p:nvPr/>
        </p:nvSpPr>
        <p:spPr>
          <a:xfrm>
            <a:off x="9130748" y="6377523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4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17152913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71700" y="647700"/>
            <a:ext cx="7848600" cy="5562600"/>
          </a:xfrm>
          <a:prstGeom prst="rect">
            <a:avLst/>
          </a:prstGeom>
        </p:spPr>
      </p:pic>
      <p:sp>
        <p:nvSpPr>
          <p:cNvPr id="3" name="CuadroTexto 2"/>
          <p:cNvSpPr txBox="1"/>
          <p:nvPr/>
        </p:nvSpPr>
        <p:spPr>
          <a:xfrm rot="16200000">
            <a:off x="542125" y="2834160"/>
            <a:ext cx="3458815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s-CL" sz="2400" dirty="0"/>
              <a:t>          CSi </a:t>
            </a:r>
            <a:r>
              <a:rPr lang="en-US" sz="2400" dirty="0"/>
              <a:t>Index</a:t>
            </a:r>
          </a:p>
        </p:txBody>
      </p:sp>
      <p:sp>
        <p:nvSpPr>
          <p:cNvPr id="4" name="CuadroTexto 3"/>
          <p:cNvSpPr txBox="1"/>
          <p:nvPr/>
        </p:nvSpPr>
        <p:spPr>
          <a:xfrm>
            <a:off x="2769704" y="5966840"/>
            <a:ext cx="226662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    Lower</a:t>
            </a:r>
          </a:p>
        </p:txBody>
      </p:sp>
      <p:sp>
        <p:nvSpPr>
          <p:cNvPr id="5" name="CuadroTexto 4"/>
          <p:cNvSpPr txBox="1"/>
          <p:nvPr/>
        </p:nvSpPr>
        <p:spPr>
          <a:xfrm>
            <a:off x="5036331" y="5912273"/>
            <a:ext cx="248895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       Middle</a:t>
            </a:r>
          </a:p>
        </p:txBody>
      </p:sp>
      <p:sp>
        <p:nvSpPr>
          <p:cNvPr id="6" name="CuadroTexto 5"/>
          <p:cNvSpPr txBox="1"/>
          <p:nvPr/>
        </p:nvSpPr>
        <p:spPr>
          <a:xfrm>
            <a:off x="7525286" y="5912273"/>
            <a:ext cx="249501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dirty="0"/>
              <a:t>                Upper</a:t>
            </a:r>
          </a:p>
        </p:txBody>
      </p:sp>
      <p:sp>
        <p:nvSpPr>
          <p:cNvPr id="8" name="CuadroTexto 7"/>
          <p:cNvSpPr txBox="1"/>
          <p:nvPr/>
        </p:nvSpPr>
        <p:spPr>
          <a:xfrm>
            <a:off x="1891334" y="6251275"/>
            <a:ext cx="8048896" cy="46166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2400" dirty="0"/>
              <a:t>                        High Molecular Weight Adiponectin </a:t>
            </a:r>
            <a:r>
              <a:rPr lang="es-CL" sz="2400" dirty="0"/>
              <a:t>(µg/ml)</a:t>
            </a:r>
            <a:endParaRPr lang="en-US" sz="2400" dirty="0"/>
          </a:p>
        </p:txBody>
      </p:sp>
      <p:sp>
        <p:nvSpPr>
          <p:cNvPr id="9" name="CuadroTexto 8"/>
          <p:cNvSpPr txBox="1"/>
          <p:nvPr/>
        </p:nvSpPr>
        <p:spPr>
          <a:xfrm>
            <a:off x="9052891" y="6384583"/>
            <a:ext cx="30612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L" dirty="0"/>
              <a:t>Figure 4 </a:t>
            </a:r>
            <a:r>
              <a:rPr lang="es-CL" dirty="0" err="1"/>
              <a:t>supplemental</a:t>
            </a:r>
            <a:r>
              <a:rPr lang="es-CL" dirty="0"/>
              <a:t> data</a:t>
            </a:r>
          </a:p>
        </p:txBody>
      </p:sp>
    </p:spTree>
    <p:extLst>
      <p:ext uri="{BB962C8B-B14F-4D97-AF65-F5344CB8AC3E}">
        <p14:creationId xmlns:p14="http://schemas.microsoft.com/office/powerpoint/2010/main" val="23621977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Panorámica</PresentationFormat>
  <Paragraphs>36</Paragraphs>
  <Slides>6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ito Bravo</dc:creator>
  <cp:lastModifiedBy>Carito Bravo</cp:lastModifiedBy>
  <cp:revision>1</cp:revision>
  <dcterms:created xsi:type="dcterms:W3CDTF">2017-03-27T14:48:08Z</dcterms:created>
  <dcterms:modified xsi:type="dcterms:W3CDTF">2017-03-27T14:48:23Z</dcterms:modified>
</cp:coreProperties>
</file>